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85" r:id="rId2"/>
    <p:sldId id="288" r:id="rId3"/>
    <p:sldId id="280" r:id="rId4"/>
    <p:sldId id="279" r:id="rId5"/>
    <p:sldId id="287" r:id="rId6"/>
    <p:sldId id="282" r:id="rId7"/>
  </p:sldIdLst>
  <p:sldSz cx="6858000" cy="9144000" type="letter"/>
  <p:notesSz cx="7315200" cy="9601200"/>
  <p:defaultTextStyle>
    <a:defPPr>
      <a:defRPr lang="en-US"/>
    </a:defPPr>
    <a:lvl1pPr marL="0" algn="l" defTabSz="546413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546413" algn="l" defTabSz="546413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092827" algn="l" defTabSz="546413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1639239" algn="l" defTabSz="546413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2185653" algn="l" defTabSz="546413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2732067" algn="l" defTabSz="546413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3278480" algn="l" defTabSz="546413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3824892" algn="l" defTabSz="546413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4371305" algn="l" defTabSz="546413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4254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50"/>
    <a:srgbClr val="3B3B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E8034E78-7F5D-4C2E-B375-FC64B27BC917}" styleName="Dunkle Formatvorlag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45" autoAdjust="0"/>
    <p:restoredTop sz="94660"/>
  </p:normalViewPr>
  <p:slideViewPr>
    <p:cSldViewPr snapToGrid="0" snapToObjects="1">
      <p:cViewPr varScale="1">
        <p:scale>
          <a:sx n="82" d="100"/>
          <a:sy n="82" d="100"/>
        </p:scale>
        <p:origin x="2988" y="84"/>
      </p:cViewPr>
      <p:guideLst>
        <p:guide orient="horz" pos="2880"/>
        <p:guide pos="2160"/>
        <p:guide orient="horz" pos="4254"/>
        <p:guide pos="431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39" tIns="48320" rIns="96639" bIns="483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4011" y="0"/>
            <a:ext cx="3169920" cy="480060"/>
          </a:xfrm>
          <a:prstGeom prst="rect">
            <a:avLst/>
          </a:prstGeom>
        </p:spPr>
        <p:txBody>
          <a:bodyPr vert="horz" lIns="96639" tIns="48320" rIns="96639" bIns="48320" rtlCol="0"/>
          <a:lstStyle>
            <a:lvl1pPr algn="r">
              <a:defRPr sz="1200"/>
            </a:lvl1pPr>
          </a:lstStyle>
          <a:p>
            <a:fld id="{94A6F57C-AF77-0849-B101-8ADCE69525C6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19138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9" tIns="48320" rIns="96639" bIns="483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39" tIns="48320" rIns="96639" bIns="483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8918"/>
            <a:ext cx="3169920" cy="480060"/>
          </a:xfrm>
          <a:prstGeom prst="rect">
            <a:avLst/>
          </a:prstGeom>
        </p:spPr>
        <p:txBody>
          <a:bodyPr vert="horz" lIns="96639" tIns="48320" rIns="96639" bIns="483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4011" y="9118918"/>
            <a:ext cx="3169920" cy="480060"/>
          </a:xfrm>
          <a:prstGeom prst="rect">
            <a:avLst/>
          </a:prstGeom>
        </p:spPr>
        <p:txBody>
          <a:bodyPr vert="horz" lIns="96639" tIns="48320" rIns="96639" bIns="48320" rtlCol="0" anchor="b"/>
          <a:lstStyle>
            <a:lvl1pPr algn="r">
              <a:defRPr sz="1200"/>
            </a:lvl1pPr>
          </a:lstStyle>
          <a:p>
            <a:fld id="{016E7827-9DCC-5C46-856B-27FB559F17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56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4641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546413" algn="l" defTabSz="54641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1092827" algn="l" defTabSz="54641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639239" algn="l" defTabSz="54641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2185653" algn="l" defTabSz="54641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2732067" algn="l" defTabSz="54641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3278480" algn="l" defTabSz="54641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3824892" algn="l" defTabSz="54641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4371305" algn="l" defTabSz="546413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6E7827-9DCC-5C46-856B-27FB559F172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1957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2840571"/>
            <a:ext cx="5829300" cy="196003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076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153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230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307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384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46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1537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4614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883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024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516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525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2"/>
          </a:xfrm>
        </p:spPr>
        <p:txBody>
          <a:bodyPr anchor="t"/>
          <a:lstStyle>
            <a:lvl1pPr algn="l">
              <a:defRPr sz="270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51"/>
          </a:xfrm>
        </p:spPr>
        <p:txBody>
          <a:bodyPr anchor="b"/>
          <a:lstStyle>
            <a:lvl1pPr marL="0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1pPr>
            <a:lvl2pPr marL="307685" indent="0">
              <a:buNone/>
              <a:defRPr sz="1295">
                <a:solidFill>
                  <a:schemeClr val="tx1">
                    <a:tint val="75000"/>
                  </a:schemeClr>
                </a:solidFill>
              </a:defRPr>
            </a:lvl2pPr>
            <a:lvl3pPr marL="615371" indent="0">
              <a:buNone/>
              <a:defRPr sz="1070">
                <a:solidFill>
                  <a:schemeClr val="tx1">
                    <a:tint val="75000"/>
                  </a:schemeClr>
                </a:solidFill>
              </a:defRPr>
            </a:lvl3pPr>
            <a:lvl4pPr marL="923055" indent="0">
              <a:buNone/>
              <a:defRPr sz="957">
                <a:solidFill>
                  <a:schemeClr val="tx1">
                    <a:tint val="75000"/>
                  </a:schemeClr>
                </a:solidFill>
              </a:defRPr>
            </a:lvl4pPr>
            <a:lvl5pPr marL="1230741" indent="0">
              <a:buNone/>
              <a:defRPr sz="957">
                <a:solidFill>
                  <a:schemeClr val="tx1">
                    <a:tint val="75000"/>
                  </a:schemeClr>
                </a:solidFill>
              </a:defRPr>
            </a:lvl5pPr>
            <a:lvl6pPr marL="1538427" indent="0">
              <a:buNone/>
              <a:defRPr sz="957">
                <a:solidFill>
                  <a:schemeClr val="tx1">
                    <a:tint val="75000"/>
                  </a:schemeClr>
                </a:solidFill>
              </a:defRPr>
            </a:lvl6pPr>
            <a:lvl7pPr marL="1846112" indent="0">
              <a:buNone/>
              <a:defRPr sz="957">
                <a:solidFill>
                  <a:schemeClr val="tx1">
                    <a:tint val="75000"/>
                  </a:schemeClr>
                </a:solidFill>
              </a:defRPr>
            </a:lvl7pPr>
            <a:lvl8pPr marL="2153797" indent="0">
              <a:buNone/>
              <a:defRPr sz="957">
                <a:solidFill>
                  <a:schemeClr val="tx1">
                    <a:tint val="75000"/>
                  </a:schemeClr>
                </a:solidFill>
              </a:defRPr>
            </a:lvl8pPr>
            <a:lvl9pPr marL="2461482" indent="0">
              <a:buNone/>
              <a:defRPr sz="95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1409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28950" cy="6034619"/>
          </a:xfrm>
        </p:spPr>
        <p:txBody>
          <a:bodyPr/>
          <a:lstStyle>
            <a:lvl1pPr>
              <a:defRPr sz="1858"/>
            </a:lvl1pPr>
            <a:lvl2pPr>
              <a:defRPr sz="1633"/>
            </a:lvl2pPr>
            <a:lvl3pPr>
              <a:defRPr sz="1351"/>
            </a:lvl3pPr>
            <a:lvl4pPr>
              <a:defRPr sz="1295"/>
            </a:lvl4pPr>
            <a:lvl5pPr>
              <a:defRPr sz="1295"/>
            </a:lvl5pPr>
            <a:lvl6pPr>
              <a:defRPr sz="1295"/>
            </a:lvl6pPr>
            <a:lvl7pPr>
              <a:defRPr sz="1295"/>
            </a:lvl7pPr>
            <a:lvl8pPr>
              <a:defRPr sz="1295"/>
            </a:lvl8pPr>
            <a:lvl9pPr>
              <a:defRPr sz="129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0"/>
            <a:ext cx="3028950" cy="6034619"/>
          </a:xfrm>
        </p:spPr>
        <p:txBody>
          <a:bodyPr/>
          <a:lstStyle>
            <a:lvl1pPr>
              <a:defRPr sz="1858"/>
            </a:lvl1pPr>
            <a:lvl2pPr>
              <a:defRPr sz="1633"/>
            </a:lvl2pPr>
            <a:lvl3pPr>
              <a:defRPr sz="1351"/>
            </a:lvl3pPr>
            <a:lvl4pPr>
              <a:defRPr sz="1295"/>
            </a:lvl4pPr>
            <a:lvl5pPr>
              <a:defRPr sz="1295"/>
            </a:lvl5pPr>
            <a:lvl6pPr>
              <a:defRPr sz="1295"/>
            </a:lvl6pPr>
            <a:lvl7pPr>
              <a:defRPr sz="1295"/>
            </a:lvl7pPr>
            <a:lvl8pPr>
              <a:defRPr sz="1295"/>
            </a:lvl8pPr>
            <a:lvl9pPr>
              <a:defRPr sz="129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949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9"/>
            <a:ext cx="3030141" cy="853016"/>
          </a:xfrm>
        </p:spPr>
        <p:txBody>
          <a:bodyPr anchor="b"/>
          <a:lstStyle>
            <a:lvl1pPr marL="0" indent="0">
              <a:buNone/>
              <a:defRPr sz="1633" b="1"/>
            </a:lvl1pPr>
            <a:lvl2pPr marL="307685" indent="0">
              <a:buNone/>
              <a:defRPr sz="1351" b="1"/>
            </a:lvl2pPr>
            <a:lvl3pPr marL="615371" indent="0">
              <a:buNone/>
              <a:defRPr sz="1295" b="1"/>
            </a:lvl3pPr>
            <a:lvl4pPr marL="923055" indent="0">
              <a:buNone/>
              <a:defRPr sz="1070" b="1"/>
            </a:lvl4pPr>
            <a:lvl5pPr marL="1230741" indent="0">
              <a:buNone/>
              <a:defRPr sz="1070" b="1"/>
            </a:lvl5pPr>
            <a:lvl6pPr marL="1538427" indent="0">
              <a:buNone/>
              <a:defRPr sz="1070" b="1"/>
            </a:lvl6pPr>
            <a:lvl7pPr marL="1846112" indent="0">
              <a:buNone/>
              <a:defRPr sz="1070" b="1"/>
            </a:lvl7pPr>
            <a:lvl8pPr marL="2153797" indent="0">
              <a:buNone/>
              <a:defRPr sz="1070" b="1"/>
            </a:lvl8pPr>
            <a:lvl9pPr marL="2461482" indent="0">
              <a:buNone/>
              <a:defRPr sz="107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4"/>
            <a:ext cx="3030141" cy="5268384"/>
          </a:xfrm>
        </p:spPr>
        <p:txBody>
          <a:bodyPr/>
          <a:lstStyle>
            <a:lvl1pPr>
              <a:defRPr sz="1633"/>
            </a:lvl1pPr>
            <a:lvl2pPr>
              <a:defRPr sz="1351"/>
            </a:lvl2pPr>
            <a:lvl3pPr>
              <a:defRPr sz="1295"/>
            </a:lvl3pPr>
            <a:lvl4pPr>
              <a:defRPr sz="1070"/>
            </a:lvl4pPr>
            <a:lvl5pPr>
              <a:defRPr sz="1070"/>
            </a:lvl5pPr>
            <a:lvl6pPr>
              <a:defRPr sz="1070"/>
            </a:lvl6pPr>
            <a:lvl7pPr>
              <a:defRPr sz="1070"/>
            </a:lvl7pPr>
            <a:lvl8pPr>
              <a:defRPr sz="1070"/>
            </a:lvl8pPr>
            <a:lvl9pPr>
              <a:defRPr sz="107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9"/>
            <a:ext cx="3031331" cy="853016"/>
          </a:xfrm>
        </p:spPr>
        <p:txBody>
          <a:bodyPr anchor="b"/>
          <a:lstStyle>
            <a:lvl1pPr marL="0" indent="0">
              <a:buNone/>
              <a:defRPr sz="1633" b="1"/>
            </a:lvl1pPr>
            <a:lvl2pPr marL="307685" indent="0">
              <a:buNone/>
              <a:defRPr sz="1351" b="1"/>
            </a:lvl2pPr>
            <a:lvl3pPr marL="615371" indent="0">
              <a:buNone/>
              <a:defRPr sz="1295" b="1"/>
            </a:lvl3pPr>
            <a:lvl4pPr marL="923055" indent="0">
              <a:buNone/>
              <a:defRPr sz="1070" b="1"/>
            </a:lvl4pPr>
            <a:lvl5pPr marL="1230741" indent="0">
              <a:buNone/>
              <a:defRPr sz="1070" b="1"/>
            </a:lvl5pPr>
            <a:lvl6pPr marL="1538427" indent="0">
              <a:buNone/>
              <a:defRPr sz="1070" b="1"/>
            </a:lvl6pPr>
            <a:lvl7pPr marL="1846112" indent="0">
              <a:buNone/>
              <a:defRPr sz="1070" b="1"/>
            </a:lvl7pPr>
            <a:lvl8pPr marL="2153797" indent="0">
              <a:buNone/>
              <a:defRPr sz="1070" b="1"/>
            </a:lvl8pPr>
            <a:lvl9pPr marL="2461482" indent="0">
              <a:buNone/>
              <a:defRPr sz="107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4"/>
            <a:ext cx="3031331" cy="5268384"/>
          </a:xfrm>
        </p:spPr>
        <p:txBody>
          <a:bodyPr/>
          <a:lstStyle>
            <a:lvl1pPr>
              <a:defRPr sz="1633"/>
            </a:lvl1pPr>
            <a:lvl2pPr>
              <a:defRPr sz="1351"/>
            </a:lvl2pPr>
            <a:lvl3pPr>
              <a:defRPr sz="1295"/>
            </a:lvl3pPr>
            <a:lvl4pPr>
              <a:defRPr sz="1070"/>
            </a:lvl4pPr>
            <a:lvl5pPr>
              <a:defRPr sz="1070"/>
            </a:lvl5pPr>
            <a:lvl6pPr>
              <a:defRPr sz="1070"/>
            </a:lvl6pPr>
            <a:lvl7pPr>
              <a:defRPr sz="1070"/>
            </a:lvl7pPr>
            <a:lvl8pPr>
              <a:defRPr sz="1070"/>
            </a:lvl8pPr>
            <a:lvl9pPr>
              <a:defRPr sz="107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478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239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666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8"/>
            <a:ext cx="2256234" cy="1549400"/>
          </a:xfrm>
        </p:spPr>
        <p:txBody>
          <a:bodyPr anchor="b"/>
          <a:lstStyle>
            <a:lvl1pPr algn="l">
              <a:defRPr sz="1351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70"/>
            <a:ext cx="3833813" cy="7804150"/>
          </a:xfrm>
        </p:spPr>
        <p:txBody>
          <a:bodyPr/>
          <a:lstStyle>
            <a:lvl1pPr>
              <a:defRPr sz="2196"/>
            </a:lvl1pPr>
            <a:lvl2pPr>
              <a:defRPr sz="1858"/>
            </a:lvl2pPr>
            <a:lvl3pPr>
              <a:defRPr sz="1633"/>
            </a:lvl3pPr>
            <a:lvl4pPr>
              <a:defRPr sz="1351"/>
            </a:lvl4pPr>
            <a:lvl5pPr>
              <a:defRPr sz="1351"/>
            </a:lvl5pPr>
            <a:lvl6pPr>
              <a:defRPr sz="1351"/>
            </a:lvl6pPr>
            <a:lvl7pPr>
              <a:defRPr sz="1351"/>
            </a:lvl7pPr>
            <a:lvl8pPr>
              <a:defRPr sz="1351"/>
            </a:lvl8pPr>
            <a:lvl9pPr>
              <a:defRPr sz="135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70"/>
            <a:ext cx="2256234" cy="6254750"/>
          </a:xfrm>
        </p:spPr>
        <p:txBody>
          <a:bodyPr/>
          <a:lstStyle>
            <a:lvl1pPr marL="0" indent="0">
              <a:buNone/>
              <a:defRPr sz="957"/>
            </a:lvl1pPr>
            <a:lvl2pPr marL="307685" indent="0">
              <a:buNone/>
              <a:defRPr sz="845"/>
            </a:lvl2pPr>
            <a:lvl3pPr marL="615371" indent="0">
              <a:buNone/>
              <a:defRPr sz="676"/>
            </a:lvl3pPr>
            <a:lvl4pPr marL="923055" indent="0">
              <a:buNone/>
              <a:defRPr sz="619"/>
            </a:lvl4pPr>
            <a:lvl5pPr marL="1230741" indent="0">
              <a:buNone/>
              <a:defRPr sz="619"/>
            </a:lvl5pPr>
            <a:lvl6pPr marL="1538427" indent="0">
              <a:buNone/>
              <a:defRPr sz="619"/>
            </a:lvl6pPr>
            <a:lvl7pPr marL="1846112" indent="0">
              <a:buNone/>
              <a:defRPr sz="619"/>
            </a:lvl7pPr>
            <a:lvl8pPr marL="2153797" indent="0">
              <a:buNone/>
              <a:defRPr sz="619"/>
            </a:lvl8pPr>
            <a:lvl9pPr marL="2461482" indent="0">
              <a:buNone/>
              <a:defRPr sz="61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620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1351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6"/>
            <a:ext cx="4114800" cy="5486400"/>
          </a:xfrm>
        </p:spPr>
        <p:txBody>
          <a:bodyPr/>
          <a:lstStyle>
            <a:lvl1pPr marL="0" indent="0">
              <a:buNone/>
              <a:defRPr sz="2196"/>
            </a:lvl1pPr>
            <a:lvl2pPr marL="307685" indent="0">
              <a:buNone/>
              <a:defRPr sz="1858"/>
            </a:lvl2pPr>
            <a:lvl3pPr marL="615371" indent="0">
              <a:buNone/>
              <a:defRPr sz="1633"/>
            </a:lvl3pPr>
            <a:lvl4pPr marL="923055" indent="0">
              <a:buNone/>
              <a:defRPr sz="1351"/>
            </a:lvl4pPr>
            <a:lvl5pPr marL="1230741" indent="0">
              <a:buNone/>
              <a:defRPr sz="1351"/>
            </a:lvl5pPr>
            <a:lvl6pPr marL="1538427" indent="0">
              <a:buNone/>
              <a:defRPr sz="1351"/>
            </a:lvl6pPr>
            <a:lvl7pPr marL="1846112" indent="0">
              <a:buNone/>
              <a:defRPr sz="1351"/>
            </a:lvl7pPr>
            <a:lvl8pPr marL="2153797" indent="0">
              <a:buNone/>
              <a:defRPr sz="1351"/>
            </a:lvl8pPr>
            <a:lvl9pPr marL="2461482" indent="0">
              <a:buNone/>
              <a:defRPr sz="1351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957"/>
            </a:lvl1pPr>
            <a:lvl2pPr marL="307685" indent="0">
              <a:buNone/>
              <a:defRPr sz="845"/>
            </a:lvl2pPr>
            <a:lvl3pPr marL="615371" indent="0">
              <a:buNone/>
              <a:defRPr sz="676"/>
            </a:lvl3pPr>
            <a:lvl4pPr marL="923055" indent="0">
              <a:buNone/>
              <a:defRPr sz="619"/>
            </a:lvl4pPr>
            <a:lvl5pPr marL="1230741" indent="0">
              <a:buNone/>
              <a:defRPr sz="619"/>
            </a:lvl5pPr>
            <a:lvl6pPr marL="1538427" indent="0">
              <a:buNone/>
              <a:defRPr sz="619"/>
            </a:lvl6pPr>
            <a:lvl7pPr marL="1846112" indent="0">
              <a:buNone/>
              <a:defRPr sz="619"/>
            </a:lvl7pPr>
            <a:lvl8pPr marL="2153797" indent="0">
              <a:buNone/>
              <a:defRPr sz="619"/>
            </a:lvl8pPr>
            <a:lvl9pPr marL="2461482" indent="0">
              <a:buNone/>
              <a:defRPr sz="61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232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1"/>
          </a:xfrm>
          <a:prstGeom prst="rect">
            <a:avLst/>
          </a:prstGeom>
        </p:spPr>
        <p:txBody>
          <a:bodyPr vert="horz" lIns="109282" tIns="54641" rIns="109282" bIns="54641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0"/>
            <a:ext cx="6172200" cy="6034619"/>
          </a:xfrm>
          <a:prstGeom prst="rect">
            <a:avLst/>
          </a:prstGeom>
        </p:spPr>
        <p:txBody>
          <a:bodyPr vert="horz" lIns="109282" tIns="54641" rIns="109282" bIns="5464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1" y="8475136"/>
            <a:ext cx="1600200" cy="486835"/>
          </a:xfrm>
          <a:prstGeom prst="rect">
            <a:avLst/>
          </a:prstGeom>
        </p:spPr>
        <p:txBody>
          <a:bodyPr vert="horz" lIns="109282" tIns="54641" rIns="109282" bIns="54641" rtlCol="0" anchor="ctr"/>
          <a:lstStyle>
            <a:lvl1pPr algn="l">
              <a:defRPr sz="8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FD50F2-4BC5-F44E-9C10-9209D3BF28A0}" type="datetimeFigureOut">
              <a:rPr lang="en-US" smtClean="0"/>
              <a:t>9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5"/>
          </a:xfrm>
          <a:prstGeom prst="rect">
            <a:avLst/>
          </a:prstGeom>
        </p:spPr>
        <p:txBody>
          <a:bodyPr vert="horz" lIns="109282" tIns="54641" rIns="109282" bIns="54641" rtlCol="0" anchor="ctr"/>
          <a:lstStyle>
            <a:lvl1pPr algn="ctr">
              <a:defRPr sz="8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5"/>
          </a:xfrm>
          <a:prstGeom prst="rect">
            <a:avLst/>
          </a:prstGeom>
        </p:spPr>
        <p:txBody>
          <a:bodyPr vert="horz" lIns="109282" tIns="54641" rIns="109282" bIns="54641" rtlCol="0" anchor="ctr"/>
          <a:lstStyle>
            <a:lvl1pPr algn="r">
              <a:defRPr sz="8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3B97D-BC98-A74B-98B0-614CD1B8D9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729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07685" rtl="0" eaLnBrk="1" latinLnBrk="0" hangingPunct="1">
        <a:spcBef>
          <a:spcPct val="0"/>
        </a:spcBef>
        <a:buNone/>
        <a:defRPr sz="29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0764" indent="-230764" algn="l" defTabSz="307685" rtl="0" eaLnBrk="1" latinLnBrk="0" hangingPunct="1">
        <a:spcBef>
          <a:spcPct val="20000"/>
        </a:spcBef>
        <a:buFont typeface="Arial"/>
        <a:buChar char="•"/>
        <a:defRPr sz="2196" kern="1200">
          <a:solidFill>
            <a:schemeClr val="tx1"/>
          </a:solidFill>
          <a:latin typeface="+mn-lt"/>
          <a:ea typeface="+mn-ea"/>
          <a:cs typeface="+mn-cs"/>
        </a:defRPr>
      </a:lvl1pPr>
      <a:lvl2pPr marL="499989" indent="-192303" algn="l" defTabSz="307685" rtl="0" eaLnBrk="1" latinLnBrk="0" hangingPunct="1">
        <a:spcBef>
          <a:spcPct val="20000"/>
        </a:spcBef>
        <a:buFont typeface="Arial"/>
        <a:buChar char="–"/>
        <a:defRPr sz="1858" kern="1200">
          <a:solidFill>
            <a:schemeClr val="tx1"/>
          </a:solidFill>
          <a:latin typeface="+mn-lt"/>
          <a:ea typeface="+mn-ea"/>
          <a:cs typeface="+mn-cs"/>
        </a:defRPr>
      </a:lvl2pPr>
      <a:lvl3pPr marL="769213" indent="-153843" algn="l" defTabSz="307685" rtl="0" eaLnBrk="1" latinLnBrk="0" hangingPunct="1">
        <a:spcBef>
          <a:spcPct val="20000"/>
        </a:spcBef>
        <a:buFont typeface="Arial"/>
        <a:buChar char="•"/>
        <a:defRPr sz="1633" kern="1200">
          <a:solidFill>
            <a:schemeClr val="tx1"/>
          </a:solidFill>
          <a:latin typeface="+mn-lt"/>
          <a:ea typeface="+mn-ea"/>
          <a:cs typeface="+mn-cs"/>
        </a:defRPr>
      </a:lvl3pPr>
      <a:lvl4pPr marL="1076898" indent="-153843" algn="l" defTabSz="307685" rtl="0" eaLnBrk="1" latinLnBrk="0" hangingPunct="1">
        <a:spcBef>
          <a:spcPct val="20000"/>
        </a:spcBef>
        <a:buFont typeface="Arial"/>
        <a:buChar char="–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84584" indent="-153843" algn="l" defTabSz="307685" rtl="0" eaLnBrk="1" latinLnBrk="0" hangingPunct="1">
        <a:spcBef>
          <a:spcPct val="20000"/>
        </a:spcBef>
        <a:buFont typeface="Arial"/>
        <a:buChar char="»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692269" indent="-153843" algn="l" defTabSz="307685" rtl="0" eaLnBrk="1" latinLnBrk="0" hangingPunct="1">
        <a:spcBef>
          <a:spcPct val="20000"/>
        </a:spcBef>
        <a:buFont typeface="Arial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1999954" indent="-153843" algn="l" defTabSz="307685" rtl="0" eaLnBrk="1" latinLnBrk="0" hangingPunct="1">
        <a:spcBef>
          <a:spcPct val="20000"/>
        </a:spcBef>
        <a:buFont typeface="Arial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307640" indent="-153843" algn="l" defTabSz="307685" rtl="0" eaLnBrk="1" latinLnBrk="0" hangingPunct="1">
        <a:spcBef>
          <a:spcPct val="20000"/>
        </a:spcBef>
        <a:buFont typeface="Arial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615325" indent="-153843" algn="l" defTabSz="307685" rtl="0" eaLnBrk="1" latinLnBrk="0" hangingPunct="1">
        <a:spcBef>
          <a:spcPct val="20000"/>
        </a:spcBef>
        <a:buFont typeface="Arial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7685" rtl="0" eaLnBrk="1" latinLnBrk="0" hangingPunct="1">
        <a:defRPr sz="1295" kern="1200">
          <a:solidFill>
            <a:schemeClr val="tx1"/>
          </a:solidFill>
          <a:latin typeface="+mn-lt"/>
          <a:ea typeface="+mn-ea"/>
          <a:cs typeface="+mn-cs"/>
        </a:defRPr>
      </a:lvl1pPr>
      <a:lvl2pPr marL="307685" algn="l" defTabSz="307685" rtl="0" eaLnBrk="1" latinLnBrk="0" hangingPunct="1">
        <a:defRPr sz="1295" kern="1200">
          <a:solidFill>
            <a:schemeClr val="tx1"/>
          </a:solidFill>
          <a:latin typeface="+mn-lt"/>
          <a:ea typeface="+mn-ea"/>
          <a:cs typeface="+mn-cs"/>
        </a:defRPr>
      </a:lvl2pPr>
      <a:lvl3pPr marL="615371" algn="l" defTabSz="307685" rtl="0" eaLnBrk="1" latinLnBrk="0" hangingPunct="1">
        <a:defRPr sz="1295" kern="1200">
          <a:solidFill>
            <a:schemeClr val="tx1"/>
          </a:solidFill>
          <a:latin typeface="+mn-lt"/>
          <a:ea typeface="+mn-ea"/>
          <a:cs typeface="+mn-cs"/>
        </a:defRPr>
      </a:lvl3pPr>
      <a:lvl4pPr marL="923055" algn="l" defTabSz="307685" rtl="0" eaLnBrk="1" latinLnBrk="0" hangingPunct="1">
        <a:defRPr sz="1295" kern="1200">
          <a:solidFill>
            <a:schemeClr val="tx1"/>
          </a:solidFill>
          <a:latin typeface="+mn-lt"/>
          <a:ea typeface="+mn-ea"/>
          <a:cs typeface="+mn-cs"/>
        </a:defRPr>
      </a:lvl4pPr>
      <a:lvl5pPr marL="1230741" algn="l" defTabSz="307685" rtl="0" eaLnBrk="1" latinLnBrk="0" hangingPunct="1">
        <a:defRPr sz="1295" kern="1200">
          <a:solidFill>
            <a:schemeClr val="tx1"/>
          </a:solidFill>
          <a:latin typeface="+mn-lt"/>
          <a:ea typeface="+mn-ea"/>
          <a:cs typeface="+mn-cs"/>
        </a:defRPr>
      </a:lvl5pPr>
      <a:lvl6pPr marL="1538427" algn="l" defTabSz="307685" rtl="0" eaLnBrk="1" latinLnBrk="0" hangingPunct="1">
        <a:defRPr sz="1295" kern="1200">
          <a:solidFill>
            <a:schemeClr val="tx1"/>
          </a:solidFill>
          <a:latin typeface="+mn-lt"/>
          <a:ea typeface="+mn-ea"/>
          <a:cs typeface="+mn-cs"/>
        </a:defRPr>
      </a:lvl6pPr>
      <a:lvl7pPr marL="1846112" algn="l" defTabSz="307685" rtl="0" eaLnBrk="1" latinLnBrk="0" hangingPunct="1">
        <a:defRPr sz="1295" kern="1200">
          <a:solidFill>
            <a:schemeClr val="tx1"/>
          </a:solidFill>
          <a:latin typeface="+mn-lt"/>
          <a:ea typeface="+mn-ea"/>
          <a:cs typeface="+mn-cs"/>
        </a:defRPr>
      </a:lvl7pPr>
      <a:lvl8pPr marL="2153797" algn="l" defTabSz="307685" rtl="0" eaLnBrk="1" latinLnBrk="0" hangingPunct="1">
        <a:defRPr sz="1295" kern="1200">
          <a:solidFill>
            <a:schemeClr val="tx1"/>
          </a:solidFill>
          <a:latin typeface="+mn-lt"/>
          <a:ea typeface="+mn-ea"/>
          <a:cs typeface="+mn-cs"/>
        </a:defRPr>
      </a:lvl8pPr>
      <a:lvl9pPr marL="2461482" algn="l" defTabSz="307685" rtl="0" eaLnBrk="1" latinLnBrk="0" hangingPunct="1">
        <a:defRPr sz="129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224410"/>
              </p:ext>
            </p:extLst>
          </p:nvPr>
        </p:nvGraphicFramePr>
        <p:xfrm>
          <a:off x="537194" y="879728"/>
          <a:ext cx="5783609" cy="6766560"/>
        </p:xfrm>
        <a:graphic>
          <a:graphicData uri="http://schemas.openxmlformats.org/drawingml/2006/table">
            <a:tbl>
              <a:tblPr firstRow="1" lastRow="1" bandRow="1">
                <a:tableStyleId>{7E9639D4-E3E2-4D34-9284-5A2195B3D0D7}</a:tableStyleId>
              </a:tblPr>
              <a:tblGrid>
                <a:gridCol w="5543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84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7500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0019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561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4168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71770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/>
                          <a:cs typeface="Arial"/>
                        </a:rPr>
                        <a:t>HB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/>
                          <a:cs typeface="Arial"/>
                        </a:rPr>
                        <a:t>CCR5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/>
                          <a:cs typeface="Arial"/>
                        </a:rPr>
                        <a:t>IL2RG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/>
                          <a:cs typeface="Arial"/>
                        </a:rPr>
                        <a:t>RUNX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i="1" dirty="0">
                          <a:latin typeface="Arial"/>
                          <a:cs typeface="Arial"/>
                        </a:rPr>
                        <a:t>ASXL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/>
                          <a:cs typeface="Arial"/>
                        </a:rPr>
                        <a:t>Source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/>
                          <a:cs typeface="Arial"/>
                        </a:rPr>
                        <a:t>% efficiency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0.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5.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8.5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9.1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3.0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9.6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tNGFR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3.1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tNGFR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3.5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tNGFR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1.4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tNGFR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7.1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tNGFR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4.9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tNGFR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5.5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7.6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6.1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3.7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5.3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mP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7.4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415660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6.4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295763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7.4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036002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mP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0.5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456107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mP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1.2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955521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4.1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092991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30.9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76662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3.9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33594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6.7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B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mP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3.2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B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mP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30.4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B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9.2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924276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B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1.2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 err="1">
                          <a:latin typeface="Arial"/>
                          <a:cs typeface="Arial"/>
                        </a:rPr>
                        <a:t>mCherry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1.2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E2Crimson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1.8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2.9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717757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3.7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252356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24.6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001149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>
                          <a:latin typeface="Arial"/>
                          <a:cs typeface="Arial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3.1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039254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600" dirty="0" err="1">
                          <a:latin typeface="Arial"/>
                          <a:cs typeface="Arial"/>
                        </a:rPr>
                        <a:t>mCherry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/>
                          <a:cs typeface="Arial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/>
                          <a:cs typeface="Arial"/>
                        </a:rPr>
                        <a:t>18.9</a:t>
                      </a: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-792519" y="4543181"/>
            <a:ext cx="2271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/>
                <a:cs typeface="Arial"/>
              </a:rPr>
              <a:t>Single gene targeting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815418" y="398585"/>
            <a:ext cx="3227165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b="1" dirty="0">
                <a:latin typeface="Arial"/>
                <a:cs typeface="Arial"/>
              </a:rPr>
              <a:t>Supplementary file 1a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5" name="Text Box 12"/>
          <p:cNvSpPr txBox="1"/>
          <p:nvPr/>
        </p:nvSpPr>
        <p:spPr>
          <a:xfrm>
            <a:off x="-158014" y="7940565"/>
            <a:ext cx="6513120" cy="392839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=""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61535" tIns="30768" rIns="61535" bIns="30768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/>
            <a:r>
              <a:rPr lang="en-US" sz="1400" b="1" i="1" dirty="0">
                <a:latin typeface="Arial" panose="020B0604020202020204" pitchFamily="34" charset="0"/>
                <a:ea typeface="Times New Roman"/>
                <a:cs typeface="Arial" panose="020B0604020202020204" pitchFamily="34" charset="0"/>
              </a:rPr>
              <a:t>Continued on the next page</a:t>
            </a:r>
            <a:endParaRPr lang="en-US" sz="1400" i="1" dirty="0"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9546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3394379"/>
              </p:ext>
            </p:extLst>
          </p:nvPr>
        </p:nvGraphicFramePr>
        <p:xfrm>
          <a:off x="1471121" y="1317878"/>
          <a:ext cx="3915758" cy="2392680"/>
        </p:xfrm>
        <a:graphic>
          <a:graphicData uri="http://schemas.openxmlformats.org/drawingml/2006/table">
            <a:tbl>
              <a:tblPr firstRow="1" lastRow="1" bandRow="1">
                <a:tableStyleId>{7E9639D4-E3E2-4D34-9284-5A2195B3D0D7}</a:tableStyleId>
              </a:tblPr>
              <a:tblGrid>
                <a:gridCol w="80019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5618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4168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71770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/>
                          <a:cs typeface="Arial"/>
                        </a:rPr>
                        <a:t>STAG2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i="1" dirty="0">
                          <a:latin typeface="Arial"/>
                          <a:cs typeface="Arial"/>
                        </a:rPr>
                        <a:t>AAVS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/>
                          <a:cs typeface="Arial"/>
                        </a:rPr>
                        <a:t>Source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/>
                          <a:cs typeface="Arial"/>
                        </a:rPr>
                        <a:t>% efficiency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B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42.6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B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43.9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G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43.6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G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42.2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B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54.7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G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20.1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G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27.6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G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71.0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G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38.1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G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11.5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/>
                      <a:r>
                        <a:rPr lang="da-DK" sz="600" dirty="0">
                          <a:latin typeface="Arial"/>
                          <a:cs typeface="Arial"/>
                        </a:rPr>
                        <a:t>GFP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/>
                          <a:cs typeface="Arial"/>
                        </a:rPr>
                        <a:t>CB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600" b="0" i="0" u="none" strike="noStrike" dirty="0">
                          <a:effectLst/>
                          <a:latin typeface="Arial"/>
                          <a:cs typeface="Arial"/>
                        </a:rPr>
                        <a:t>14.2</a:t>
                      </a:r>
                      <a:endParaRPr lang="en-US" sz="600" b="0" i="0" u="none" strike="noStrike" dirty="0">
                        <a:effectLst/>
                        <a:latin typeface="Arial"/>
                        <a:cs typeface="Arial"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2880">
                <a:tc gridSpan="3"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US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SD (</a:t>
                      </a:r>
                      <a:r>
                        <a:rPr lang="en-US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47)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8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7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3.4</a:t>
                      </a:r>
                      <a:endParaRPr lang="en-US" sz="600" dirty="0">
                        <a:latin typeface="Arial"/>
                        <a:cs typeface="Arial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-68619" y="2344940"/>
            <a:ext cx="2271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/>
                <a:cs typeface="Arial"/>
              </a:rPr>
              <a:t>Single gene targeting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815418" y="425757"/>
            <a:ext cx="3227165" cy="69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b="1" dirty="0">
                <a:latin typeface="Arial"/>
                <a:cs typeface="Arial"/>
              </a:rPr>
              <a:t>Supplementary file 1a</a:t>
            </a:r>
            <a:endParaRPr lang="en-US" b="1" dirty="0">
              <a:latin typeface="Arial"/>
              <a:cs typeface="Arial"/>
            </a:endParaRPr>
          </a:p>
          <a:p>
            <a:pPr algn="ctr"/>
            <a:r>
              <a:rPr lang="da-DK" sz="1600" i="1" dirty="0" err="1">
                <a:latin typeface="Arial"/>
                <a:cs typeface="Arial"/>
              </a:rPr>
              <a:t>continued</a:t>
            </a:r>
            <a:r>
              <a:rPr lang="da-DK" sz="1600" i="1" dirty="0">
                <a:latin typeface="Arial"/>
                <a:cs typeface="Arial"/>
              </a:rPr>
              <a:t> from </a:t>
            </a:r>
            <a:r>
              <a:rPr lang="da-DK" sz="1600" i="1" dirty="0" err="1">
                <a:latin typeface="Arial"/>
                <a:cs typeface="Arial"/>
              </a:rPr>
              <a:t>previous</a:t>
            </a:r>
            <a:r>
              <a:rPr lang="da-DK" sz="1600" i="1" dirty="0">
                <a:latin typeface="Arial"/>
                <a:cs typeface="Arial"/>
              </a:rPr>
              <a:t> page</a:t>
            </a:r>
            <a:endParaRPr lang="en-US" sz="1600" i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804289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07402" y="398585"/>
            <a:ext cx="3243196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b="1" dirty="0">
                <a:latin typeface="Arial"/>
                <a:cs typeface="Arial"/>
              </a:rPr>
              <a:t>Supplementary file 1b</a:t>
            </a:r>
            <a:endParaRPr lang="en-US" b="1" dirty="0">
              <a:latin typeface="Arial"/>
              <a:cs typeface="Arial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5215803"/>
              </p:ext>
            </p:extLst>
          </p:nvPr>
        </p:nvGraphicFramePr>
        <p:xfrm>
          <a:off x="492706" y="1341110"/>
          <a:ext cx="2561737" cy="3822192"/>
        </p:xfrm>
        <a:graphic>
          <a:graphicData uri="http://schemas.openxmlformats.org/drawingml/2006/table">
            <a:tbl>
              <a:tblPr/>
              <a:tblGrid>
                <a:gridCol w="561700">
                  <a:extLst>
                    <a:ext uri="{9D8B030D-6E8A-4147-A177-3AD203B41FA5}">
                      <a16:colId xmlns:a16="http://schemas.microsoft.com/office/drawing/2014/main" val="850451011"/>
                    </a:ext>
                  </a:extLst>
                </a:gridCol>
                <a:gridCol w="2000037">
                  <a:extLst>
                    <a:ext uri="{9D8B030D-6E8A-4147-A177-3AD203B41FA5}">
                      <a16:colId xmlns:a16="http://schemas.microsoft.com/office/drawing/2014/main" val="2007257327"/>
                    </a:ext>
                  </a:extLst>
                </a:gridCol>
              </a:tblGrid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1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2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7104764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TGGGCTCACTATGCTGCCG (WT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863944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TGGGCTCACTATGCTGCCG (WT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646384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TGGGCTCACTATGCTGCCG (WT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1365830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TGGGCTCACTATGCTGCCG (WT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9845216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T------ACTATGCTGCCG (-6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5502130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----24BP TOTAL----CAGT (-24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820255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AC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C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C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ACTATGCTGCCG (0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7762297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AG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AA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AA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C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ACTATGCTG (+3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693467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6569264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0021490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941978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835573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657058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282131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048674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268529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674465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288874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200165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1699384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6521824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093153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89884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067410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72001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0244146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200929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256876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CTTCTTACTGTCCCCT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TGGGCTCACTATGCTGCC (+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837729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-GGGCTCACTATGCTGCCG (-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287585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-GGGCTCACTATGCTGCCG (-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0009646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-GGGCTCACTATGCTGCCG (-1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548710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--GGCTCACTATGCTGCCG (-2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106889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CC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 (+2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262803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A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-----GCTCACTATGCTGCCG (-5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8037107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----25BP TOTAL----AGTG (-25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802337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CTGACCT------38BP TOTAL------CTGCCGC (-38)</a:t>
                      </a:r>
                    </a:p>
                  </a:txBody>
                  <a:tcPr marL="4625" marR="4625" marT="4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2692692"/>
                  </a:ext>
                </a:extLst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0772121"/>
              </p:ext>
            </p:extLst>
          </p:nvPr>
        </p:nvGraphicFramePr>
        <p:xfrm>
          <a:off x="3598994" y="1341110"/>
          <a:ext cx="2598420" cy="2514600"/>
        </p:xfrm>
        <a:graphic>
          <a:graphicData uri="http://schemas.openxmlformats.org/drawingml/2006/table">
            <a:tbl>
              <a:tblPr/>
              <a:tblGrid>
                <a:gridCol w="538072">
                  <a:extLst>
                    <a:ext uri="{9D8B030D-6E8A-4147-A177-3AD203B41FA5}">
                      <a16:colId xmlns:a16="http://schemas.microsoft.com/office/drawing/2014/main" val="3954249089"/>
                    </a:ext>
                  </a:extLst>
                </a:gridCol>
                <a:gridCol w="2060348">
                  <a:extLst>
                    <a:ext uri="{9D8B030D-6E8A-4147-A177-3AD203B41FA5}">
                      <a16:colId xmlns:a16="http://schemas.microsoft.com/office/drawing/2014/main" val="4093891704"/>
                    </a:ext>
                  </a:extLst>
                </a:gridCol>
              </a:tblGrid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1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2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579520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246539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526295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795160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294044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658514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088542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2392506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166893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68579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618109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343717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325115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928709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721592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GAAGAGCAAGCGCCATGTTGAAGCCATCATTACCAT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kumimoji="0" lang="en-US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ourier New" panose="02070309020205020404" pitchFamily="49" charset="0"/>
                        <a:ea typeface="+mn-ea"/>
                        <a:cs typeface="+mn-cs"/>
                      </a:endParaRP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307468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AAGAGCAAGCGCCATGT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AAGCCATCATTACCAT (+1)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081806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AAGAGCAAGCGCCATGT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AAGCCATCATTACCAT (+1)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3169126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AAGAGCAAGCGCCATGT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AAGCCATCATTACCAT (+1)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616227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AAGAGCAAGCGCCATGT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AAGCCATCATTACCAT (+1)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430930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AAGAGCAAGCGCCAT-----------CATTACCATT (-11)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278858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AAGAGCAAGCGCCAT-----------CATTACCATT (-11)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41819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AAGAGCAAG----------AAGCCATCATTACCATT (-10)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2430244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AAGA-------------------CATCATTACCATT (-19)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007913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  Integration</a:t>
                      </a:r>
                      <a:r>
                        <a:rPr lang="en-US" sz="6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 of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 230bp of RHA</a:t>
                      </a:r>
                      <a:r>
                        <a:rPr lang="en-US" sz="6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 + ITR   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(+230)</a:t>
                      </a:r>
                    </a:p>
                  </a:txBody>
                  <a:tcPr marL="8902" marR="8902" marT="89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3812847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5975688"/>
              </p:ext>
            </p:extLst>
          </p:nvPr>
        </p:nvGraphicFramePr>
        <p:xfrm>
          <a:off x="3591374" y="4250438"/>
          <a:ext cx="2606040" cy="2625090"/>
        </p:xfrm>
        <a:graphic>
          <a:graphicData uri="http://schemas.openxmlformats.org/drawingml/2006/table">
            <a:tbl>
              <a:tblPr/>
              <a:tblGrid>
                <a:gridCol w="528145">
                  <a:extLst>
                    <a:ext uri="{9D8B030D-6E8A-4147-A177-3AD203B41FA5}">
                      <a16:colId xmlns:a16="http://schemas.microsoft.com/office/drawing/2014/main" val="1157709805"/>
                    </a:ext>
                  </a:extLst>
                </a:gridCol>
                <a:gridCol w="2077895">
                  <a:extLst>
                    <a:ext uri="{9D8B030D-6E8A-4147-A177-3AD203B41FA5}">
                      <a16:colId xmlns:a16="http://schemas.microsoft.com/office/drawing/2014/main" val="710097655"/>
                    </a:ext>
                  </a:extLst>
                </a:gridCol>
              </a:tblGrid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4051566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CACCTCTCATGAAGCACTGTGGGTACG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937851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CACCTCTCATGAAGCACTGTGGGTACG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732264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CACCTCTCATGAAGCACTGTGGGTACG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 (WT)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368210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CACCTCT---------CTGTGGGTACG (-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6876240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CACCTCT---------CTGTGGGTACG (-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92138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------------------GTGGGTACG (-1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404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418734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CACCTC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A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656967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327578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9798290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923939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176253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849905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830678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505740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870367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0306357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859683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919594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721414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1810870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GCATGTACTCACCTCTC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</a:t>
                      </a:r>
                      <a:r>
                        <a:rPr kumimoji="0" lang="en-US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ourier New" panose="02070309020205020404" pitchFamily="49" charset="0"/>
                          <a:ea typeface="+mn-ea"/>
                          <a:cs typeface="+mn-cs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280345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CACCTC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A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TGAAGCACTGTGGGTAC (+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58487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CACCTC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AA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TGAAGCACTGTGGGTA (+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414152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CATGTACTCACCTC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A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TGAAGCACTGTGGGTA (+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67792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ATCATAT-----147BP TOTAL-----ATGAAGCA (-147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3991482"/>
                  </a:ext>
                </a:extLst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492706" y="985325"/>
            <a:ext cx="2561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400" b="1" i="1" dirty="0">
                <a:latin typeface="Arial"/>
                <a:cs typeface="Arial"/>
              </a:rPr>
              <a:t>CCR5</a:t>
            </a:r>
            <a:endParaRPr lang="en-US" sz="1400" b="1" i="1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20716" y="985325"/>
            <a:ext cx="2561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400" b="1" i="1" dirty="0">
                <a:latin typeface="Arial"/>
                <a:cs typeface="Arial"/>
              </a:rPr>
              <a:t>IL2RG</a:t>
            </a:r>
            <a:endParaRPr lang="en-US" sz="1400" b="1" i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620716" y="3903785"/>
            <a:ext cx="2561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400" b="1" i="1" dirty="0">
                <a:latin typeface="Arial"/>
                <a:cs typeface="Arial"/>
              </a:rPr>
              <a:t>RUNX1</a:t>
            </a:r>
            <a:endParaRPr lang="en-US" sz="1400" b="1" i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379446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3417648"/>
              </p:ext>
            </p:extLst>
          </p:nvPr>
        </p:nvGraphicFramePr>
        <p:xfrm>
          <a:off x="673142" y="998881"/>
          <a:ext cx="5926486" cy="3345548"/>
        </p:xfrm>
        <a:graphic>
          <a:graphicData uri="http://schemas.openxmlformats.org/drawingml/2006/table">
            <a:tbl>
              <a:tblPr firstRow="1" lastRow="1" bandRow="1">
                <a:tableStyleId>{7E9639D4-E3E2-4D34-9284-5A2195B3D0D7}</a:tableStyleId>
              </a:tblPr>
              <a:tblGrid>
                <a:gridCol w="6972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84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7500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4009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62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4168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71770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r>
                        <a:rPr lang="en-US" sz="800" i="1" dirty="0"/>
                        <a:t>HBB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i="1" dirty="0"/>
                        <a:t>CCR5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i="1" dirty="0"/>
                        <a:t>IL2RG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i="1" dirty="0"/>
                        <a:t>RUNX1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/>
                        <a:t>ASXL1</a:t>
                      </a:r>
                      <a:endPara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Source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% efficiency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/</a:t>
                      </a: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GFR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/</a:t>
                      </a: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GFR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8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3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543319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244164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4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877107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 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636747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/</a:t>
                      </a: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 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7380244"/>
                  </a:ext>
                </a:extLst>
              </a:tr>
              <a:tr h="206108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/</a:t>
                      </a: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189744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/</a:t>
                      </a: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/</a:t>
                      </a: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3411484"/>
                  </a:ext>
                </a:extLst>
              </a:tr>
              <a:tr h="182880">
                <a:tc gridSpan="6"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SD (</a:t>
                      </a:r>
                      <a:r>
                        <a:rPr lang="en-US" sz="6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16)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4.2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15" name="TextBox 14"/>
          <p:cNvSpPr txBox="1"/>
          <p:nvPr/>
        </p:nvSpPr>
        <p:spPr>
          <a:xfrm rot="16200000">
            <a:off x="-1368077" y="2502378"/>
            <a:ext cx="33455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/>
                <a:cs typeface="Arial"/>
              </a:rPr>
              <a:t>Biallelic targeting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-836551" y="6007207"/>
            <a:ext cx="22860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/>
                <a:cs typeface="Arial"/>
              </a:rPr>
              <a:t>Di-genic targeting</a:t>
            </a:r>
          </a:p>
        </p:txBody>
      </p:sp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5123294"/>
              </p:ext>
            </p:extLst>
          </p:nvPr>
        </p:nvGraphicFramePr>
        <p:xfrm>
          <a:off x="673142" y="4563583"/>
          <a:ext cx="5783612" cy="3291840"/>
        </p:xfrm>
        <a:graphic>
          <a:graphicData uri="http://schemas.openxmlformats.org/drawingml/2006/table">
            <a:tbl>
              <a:tblPr firstRow="1" lastRow="1" bandRow="1">
                <a:tableStyleId>{7E9639D4-E3E2-4D34-9284-5A2195B3D0D7}</a:tableStyleId>
              </a:tblPr>
              <a:tblGrid>
                <a:gridCol w="44430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17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4100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316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7408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74084">
                  <a:extLst>
                    <a:ext uri="{9D8B030D-6E8A-4147-A177-3AD203B41FA5}">
                      <a16:colId xmlns:a16="http://schemas.microsoft.com/office/drawing/2014/main" val="2986274352"/>
                    </a:ext>
                  </a:extLst>
                </a:gridCol>
                <a:gridCol w="574084">
                  <a:extLst>
                    <a:ext uri="{9D8B030D-6E8A-4147-A177-3AD203B41FA5}">
                      <a16:colId xmlns:a16="http://schemas.microsoft.com/office/drawing/2014/main" val="4004724391"/>
                    </a:ext>
                  </a:extLst>
                </a:gridCol>
                <a:gridCol w="59444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37670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600" i="1" dirty="0"/>
                        <a:t>HBB</a:t>
                      </a:r>
                      <a:endParaRPr lang="en-US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/>
                        <a:t>CCR5</a:t>
                      </a:r>
                      <a:endParaRPr lang="en-US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/>
                        <a:t>IL2RG</a:t>
                      </a:r>
                      <a:endParaRPr lang="en-US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/>
                        <a:t>RUNX1</a:t>
                      </a:r>
                      <a:endParaRPr lang="en-US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i="1" dirty="0"/>
                        <a:t>ASXL1</a:t>
                      </a:r>
                      <a:endParaRPr lang="en-US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2</a:t>
                      </a:r>
                      <a:endParaRPr lang="en-US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VS1</a:t>
                      </a:r>
                      <a:endParaRPr lang="en-US" sz="6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/>
                        <a:t>Source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/>
                        <a:t>% efficienc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 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2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2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GFR</a:t>
                      </a: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PC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9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83285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899068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6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633962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342895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565692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1837766"/>
                  </a:ext>
                </a:extLst>
              </a:tr>
              <a:tr h="182880">
                <a:tc gridSpan="8"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SD (</a:t>
                      </a:r>
                      <a:r>
                        <a:rPr lang="en-US" sz="6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17)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8.1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815418" y="316524"/>
            <a:ext cx="3227165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b="1" dirty="0">
                <a:latin typeface="Arial"/>
                <a:cs typeface="Arial"/>
              </a:rPr>
              <a:t>Supplementary file 1c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380256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07402" y="398585"/>
            <a:ext cx="3243196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b="1" dirty="0">
                <a:latin typeface="Arial"/>
                <a:cs typeface="Arial"/>
              </a:rPr>
              <a:t>Supplementary file 1d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184650" y="1185173"/>
            <a:ext cx="2533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400" b="1" i="1" dirty="0">
                <a:latin typeface="Arial"/>
                <a:cs typeface="Arial"/>
              </a:rPr>
              <a:t>CCR5</a:t>
            </a:r>
            <a:endParaRPr lang="en-US" sz="1400" b="1" i="1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33349" y="1185173"/>
            <a:ext cx="1111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400" b="1" i="1" dirty="0">
                <a:latin typeface="Arial"/>
                <a:cs typeface="Arial"/>
              </a:rPr>
              <a:t>IL2RG</a:t>
            </a:r>
            <a:endParaRPr lang="en-US" sz="1400" b="1" i="1" dirty="0">
              <a:latin typeface="Arial"/>
              <a:cs typeface="Arial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169868"/>
              </p:ext>
            </p:extLst>
          </p:nvPr>
        </p:nvGraphicFramePr>
        <p:xfrm>
          <a:off x="141500" y="1618216"/>
          <a:ext cx="6574999" cy="1408176"/>
        </p:xfrm>
        <a:graphic>
          <a:graphicData uri="http://schemas.openxmlformats.org/drawingml/2006/table">
            <a:tbl>
              <a:tblPr/>
              <a:tblGrid>
                <a:gridCol w="5609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609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996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6096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12624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678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6096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98813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005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1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2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1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2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1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sng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llele 2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T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G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GGCTCACTATGCTGCC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C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C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TCTGCCGT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-----39BP TOTAL-----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GGTGAGGCC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C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GAGAAG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A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GC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T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C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A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CCCTGTGGGGCAAGGT (0) 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HBD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FFFFFF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TGGGCTCACTATGCTGCCG (WT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GAGAAGTCTGCCGTTA</a:t>
                      </a:r>
                      <a:r>
                        <a:rPr lang="en-US" sz="600" b="1" i="0" u="none" strike="noStrike" dirty="0">
                          <a:solidFill>
                            <a:srgbClr val="FFFF00"/>
                          </a:solidFill>
                          <a:effectLst/>
                          <a:latin typeface="Courier New" panose="02070309020205020404" pitchFamily="49" charset="0"/>
                        </a:rPr>
                        <a:t>GGGTTAGGGTTA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GCCCT (+12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C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 w="635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ourier New" panose="02070309020205020404" pitchFamily="49" charset="0"/>
                        </a:rPr>
                        <a:t>WT</a:t>
                      </a:r>
                    </a:p>
                  </a:txBody>
                  <a:tcPr marL="4259" marR="4259" marT="4259" marB="0" anchor="b">
                    <a:lnL w="635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0BF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 w="635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AGGAGAAGTCTGCCGTTA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AT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TGCCCTGTGGGGCAAGG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FFFFFF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TGGGCTCACTATGCTGCCG (WT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B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AGGAGAAGTCTGCCGTTA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C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CTGCCCTGTGGGGCAAGG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C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AGGAGAAGTCTGCCGTTA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A</a:t>
                      </a:r>
                      <a:r>
                        <a:rPr lang="en-US" sz="600" b="1" i="0" u="none" strike="noStrike" dirty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CTGCCCTGTGGGGCAAGG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GGAGAAGTCTGCCGTTA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----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CTGTGGGGCAAGGT (-4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C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  <a:endParaRPr lang="en-US" sz="600" b="0" i="0" u="none" strike="noStrike" dirty="0">
                        <a:solidFill>
                          <a:srgbClr val="0061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 of 304bp of SFFV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 of 235bp of SFFV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C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00584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N/A (male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 of 235bp of SFFV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Integration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TTCTTACTGTCCCCTTC</a:t>
                      </a:r>
                      <a:r>
                        <a:rPr lang="en-U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</a:rPr>
                        <a:t>T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GCTCACTATGCTGCC (+1)</a:t>
                      </a:r>
                    </a:p>
                  </a:txBody>
                  <a:tcPr marL="4259" marR="4259" marT="425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FF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1409700" y="1185173"/>
            <a:ext cx="2660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400" b="1" i="1" dirty="0">
                <a:latin typeface="Arial"/>
                <a:cs typeface="Arial"/>
              </a:rPr>
              <a:t>HBB</a:t>
            </a:r>
            <a:endParaRPr lang="en-US" sz="1400" b="1" i="1" dirty="0">
              <a:latin typeface="Arial"/>
              <a:cs typeface="Arial"/>
            </a:endParaRPr>
          </a:p>
        </p:txBody>
      </p:sp>
      <p:sp>
        <p:nvSpPr>
          <p:cNvPr id="7" name="Right Brace 6"/>
          <p:cNvSpPr/>
          <p:nvPr/>
        </p:nvSpPr>
        <p:spPr>
          <a:xfrm rot="16200000">
            <a:off x="592138" y="1001712"/>
            <a:ext cx="171450" cy="1108075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Brace 14"/>
          <p:cNvSpPr/>
          <p:nvPr/>
        </p:nvSpPr>
        <p:spPr>
          <a:xfrm rot="16200000">
            <a:off x="2646365" y="223837"/>
            <a:ext cx="171450" cy="2663826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ight Brace 16"/>
          <p:cNvSpPr/>
          <p:nvPr/>
        </p:nvSpPr>
        <p:spPr>
          <a:xfrm rot="16200000">
            <a:off x="5360088" y="285064"/>
            <a:ext cx="171450" cy="2541372"/>
          </a:xfrm>
          <a:prstGeom prst="righ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9012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8098850"/>
              </p:ext>
            </p:extLst>
          </p:nvPr>
        </p:nvGraphicFramePr>
        <p:xfrm>
          <a:off x="743475" y="3112296"/>
          <a:ext cx="5926486" cy="1463040"/>
        </p:xfrm>
        <a:graphic>
          <a:graphicData uri="http://schemas.openxmlformats.org/drawingml/2006/table">
            <a:tbl>
              <a:tblPr firstRow="1" lastRow="1" bandRow="1">
                <a:tableStyleId>{7E9639D4-E3E2-4D34-9284-5A2195B3D0D7}</a:tableStyleId>
              </a:tblPr>
              <a:tblGrid>
                <a:gridCol w="6972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84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7500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4009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62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4168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71770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5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2RG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NX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XL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efficiency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GR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GR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809449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456142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0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3335850"/>
                  </a:ext>
                </a:extLst>
              </a:tr>
              <a:tr h="182880">
                <a:tc gridSpan="6"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SD (</a:t>
                      </a:r>
                      <a:r>
                        <a:rPr lang="en-US" sz="6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6)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4.8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15" name="TextBox 14"/>
          <p:cNvSpPr txBox="1"/>
          <p:nvPr/>
        </p:nvSpPr>
        <p:spPr>
          <a:xfrm rot="16200000">
            <a:off x="-625034" y="3559282"/>
            <a:ext cx="1976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ri-genic targeting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-760938" y="1244489"/>
            <a:ext cx="22485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etra-allelic targeting</a:t>
            </a:r>
          </a:p>
        </p:txBody>
      </p:sp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4369019"/>
              </p:ext>
            </p:extLst>
          </p:nvPr>
        </p:nvGraphicFramePr>
        <p:xfrm>
          <a:off x="743475" y="886889"/>
          <a:ext cx="5845524" cy="914400"/>
        </p:xfrm>
        <a:graphic>
          <a:graphicData uri="http://schemas.openxmlformats.org/drawingml/2006/table">
            <a:tbl>
              <a:tblPr firstRow="1" lastRow="1" bandRow="1">
                <a:tableStyleId>{7E9639D4-E3E2-4D34-9284-5A2195B3D0D7}</a:tableStyleId>
              </a:tblPr>
              <a:tblGrid>
                <a:gridCol w="6162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00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484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3726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5743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71770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+mn-lt"/>
                        </a:rPr>
                        <a:t>HBB</a:t>
                      </a:r>
                      <a:endParaRPr lang="en-US" sz="600" i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+mn-lt"/>
                        </a:rPr>
                        <a:t>CCR5</a:t>
                      </a:r>
                      <a:endParaRPr lang="en-US" sz="600" i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+mn-lt"/>
                        </a:rPr>
                        <a:t>IL2RG</a:t>
                      </a:r>
                      <a:endParaRPr lang="en-US" sz="600" i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+mn-lt"/>
                        </a:rPr>
                        <a:t>RUNX1</a:t>
                      </a:r>
                      <a:endParaRPr lang="en-US" sz="600" i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i="1" dirty="0">
                          <a:latin typeface="+mn-lt"/>
                        </a:rPr>
                        <a:t>ASXL1</a:t>
                      </a:r>
                      <a:endParaRPr lang="en-US" sz="600" i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+mn-lt"/>
                        </a:rPr>
                        <a:t>Source</a:t>
                      </a:r>
                      <a:endParaRPr lang="en-US" sz="6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+mn-lt"/>
                        </a:rPr>
                        <a:t>% efficiency</a:t>
                      </a:r>
                      <a:endParaRPr lang="en-US" sz="6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/</a:t>
                      </a: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GFR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/</a:t>
                      </a: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/E2Crimson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/</a:t>
                      </a:r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/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E2Crimson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 gridSpan="6"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SD (</a:t>
                      </a:r>
                      <a:r>
                        <a:rPr lang="en-US" sz="6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3)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815418" y="398585"/>
            <a:ext cx="3227165" cy="4462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b="1" dirty="0">
                <a:latin typeface="Arial"/>
                <a:cs typeface="Arial"/>
              </a:rPr>
              <a:t>Supplementary file 1e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-742502" y="5956117"/>
            <a:ext cx="22116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etra-genic targeting</a:t>
            </a: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7029217"/>
              </p:ext>
            </p:extLst>
          </p:nvPr>
        </p:nvGraphicFramePr>
        <p:xfrm>
          <a:off x="743475" y="5657132"/>
          <a:ext cx="5845524" cy="914400"/>
        </p:xfrm>
        <a:graphic>
          <a:graphicData uri="http://schemas.openxmlformats.org/drawingml/2006/table">
            <a:tbl>
              <a:tblPr firstRow="1" lastRow="1" bandRow="1">
                <a:tableStyleId>{7E9639D4-E3E2-4D34-9284-5A2195B3D0D7}</a:tableStyleId>
              </a:tblPr>
              <a:tblGrid>
                <a:gridCol w="6162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00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484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3726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5743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71770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R5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2RG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NX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XL1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efficiency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GFR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GFR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307685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Tomato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GFR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da-DK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2880">
                <a:tc gridSpan="6"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SD (</a:t>
                      </a:r>
                      <a:r>
                        <a:rPr lang="en-US" sz="6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3)</a:t>
                      </a:r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 </a:t>
                      </a:r>
                      <a:r>
                        <a:rPr lang="en-US" sz="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</a:p>
                  </a:txBody>
                  <a:tcPr anchor="ctr" anchorCtr="1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36841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4</TotalTime>
  <Words>1229</Words>
  <Application>Microsoft Office PowerPoint</Application>
  <PresentationFormat>Letter Paper (8.5x11 in)</PresentationFormat>
  <Paragraphs>653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.</dc:creator>
  <cp:lastModifiedBy>Rasmus Bak</cp:lastModifiedBy>
  <cp:revision>1058</cp:revision>
  <cp:lastPrinted>2017-03-15T21:35:55Z</cp:lastPrinted>
  <dcterms:created xsi:type="dcterms:W3CDTF">2016-02-18T17:58:48Z</dcterms:created>
  <dcterms:modified xsi:type="dcterms:W3CDTF">2017-09-09T19:35:27Z</dcterms:modified>
</cp:coreProperties>
</file>